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3204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97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5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499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32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5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8990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53888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059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759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86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7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8A498-CA52-4C03-8A1D-2E811D1FDC59}" type="datetimeFigureOut">
              <a:rPr lang="en-US" smtClean="0"/>
              <a:t>2015-09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E8CFD-7EF2-4684-A729-B0F749BEA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6036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248472" y="1268993"/>
            <a:ext cx="425432" cy="1444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398716" y="384458"/>
            <a:ext cx="8700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S1_Fig.</a:t>
            </a:r>
            <a:endParaRPr lang="en-US" sz="1600" b="1" dirty="0"/>
          </a:p>
        </p:txBody>
      </p:sp>
      <p:pic>
        <p:nvPicPr>
          <p:cNvPr id="7" name="Picture 6" descr="H:\work 2011 august-december\paper 4\figure 3_19032012.pn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1182085"/>
            <a:ext cx="5972810" cy="2708031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404664" y="4067944"/>
            <a:ext cx="59728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Visualizing </a:t>
            </a:r>
            <a:r>
              <a:rPr lang="en-US" sz="1200" b="1" dirty="0"/>
              <a:t>the protein corona.</a:t>
            </a:r>
            <a:r>
              <a:rPr lang="en-US" sz="1200" dirty="0"/>
              <a:t> TEM micrographs of the ‘hard’ protein corona on CSNP and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. CSNP + protein corona without staining (A), CSNP + protein corona with negative staining (B), CSNP + protein corona with fixation and negative staining (C),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+ protein corona without staining (D), 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+ protein corona with negative staining (E), and </a:t>
            </a:r>
            <a:r>
              <a:rPr lang="en-US" sz="1200" dirty="0" err="1"/>
              <a:t>nanomag</a:t>
            </a:r>
            <a:r>
              <a:rPr lang="en-US" sz="1200" dirty="0"/>
              <a:t>®-D-</a:t>
            </a:r>
            <a:r>
              <a:rPr lang="en-US" sz="1200" dirty="0" err="1"/>
              <a:t>spio</a:t>
            </a:r>
            <a:r>
              <a:rPr lang="en-US" sz="1200" dirty="0"/>
              <a:t> + protein corona with fixation and negative staining (F). </a:t>
            </a:r>
          </a:p>
        </p:txBody>
      </p:sp>
    </p:spTree>
    <p:extLst>
      <p:ext uri="{BB962C8B-B14F-4D97-AF65-F5344CB8AC3E}">
        <p14:creationId xmlns:p14="http://schemas.microsoft.com/office/powerpoint/2010/main" val="3198390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1</TotalTime>
  <Words>9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arolinska Institutet, IM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deel, Bengt</dc:creator>
  <cp:lastModifiedBy>Fadeel, Bengt </cp:lastModifiedBy>
  <cp:revision>14</cp:revision>
  <cp:lastPrinted>2014-07-10T14:18:30Z</cp:lastPrinted>
  <dcterms:created xsi:type="dcterms:W3CDTF">2014-07-07T17:13:11Z</dcterms:created>
  <dcterms:modified xsi:type="dcterms:W3CDTF">2015-09-05T12:20:52Z</dcterms:modified>
</cp:coreProperties>
</file>